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1936">
          <p15:clr>
            <a:srgbClr val="A4A3A4"/>
          </p15:clr>
        </p15:guide>
        <p15:guide id="3" pos="3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rtier, Stephanie" initials="FS" lastIdx="4" clrIdx="0">
    <p:extLst/>
  </p:cmAuthor>
  <p:cmAuthor id="2" name="Andrew Stiff" initials="" lastIdx="0" clrIdx="1"/>
  <p:cmAuthor id="3" name="Sobrina Wesolowski" initials="SW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03" autoAdjust="0"/>
    <p:restoredTop sz="93918" autoAdjust="0"/>
  </p:normalViewPr>
  <p:slideViewPr>
    <p:cSldViewPr snapToGrid="0">
      <p:cViewPr varScale="1">
        <p:scale>
          <a:sx n="48" d="100"/>
          <a:sy n="48" d="100"/>
        </p:scale>
        <p:origin x="-3108" y="-120"/>
      </p:cViewPr>
      <p:guideLst>
        <p:guide orient="horz" pos="3840"/>
        <p:guide pos="1936"/>
        <p:guide pos="3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BB1863-6C78-4199-A00B-2F07DD958D56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426DA3-EA64-413C-AC60-7E90D2A03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21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0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5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7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2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786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50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66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5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74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45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443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66573" y="583682"/>
            <a:ext cx="55547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6. Percentage of TILs, CD8+ cells, PD-L1+/PD-1+ cells in TNBC samples before and after NAC.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0234131"/>
              </p:ext>
            </p:extLst>
          </p:nvPr>
        </p:nvGraphicFramePr>
        <p:xfrm>
          <a:off x="734938" y="1109715"/>
          <a:ext cx="5486401" cy="59232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57374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42097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49168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TNBC pre-NAC</a:t>
                      </a: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cohort</a:t>
                      </a:r>
                    </a:p>
                    <a:p>
                      <a:pPr algn="ctr"/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=3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TNBC post-NAC </a:t>
                      </a: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cohort</a:t>
                      </a:r>
                    </a:p>
                    <a:p>
                      <a:pPr algn="ctr"/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=9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Mean (range)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Mean</a:t>
                      </a: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(range)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8945475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tromal TIL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9.3% (3-6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6.9%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(2-70%)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Overall CD8+ cells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5.3%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(1-3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7.0% (1-50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tromal CD8+ cell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4.0% (2-5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3.0% (1-60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ntra-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tumora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CD8+ cell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6.6% (0-15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9.8% (0-40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Overall PDL1 intensity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.3% (0-3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.9% (0-20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957258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tromal PDL1 intensity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.7% (0-3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.3% (0-15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912549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ntra-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tumora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PDL1 intensity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.0% (0-3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4.4% (0-30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601940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Overall PD1 intensity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.7% (0-5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0.3% (0-1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467334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 (%)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</a:t>
                      </a: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(%)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827896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PDL1+ samples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66.7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5.6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25658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mal PDL1+ sampl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66.7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55.6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9572964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-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a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DL1+ sampl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3.3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.3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1996661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D1+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3.3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.3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162169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5619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28</TotalTime>
  <Words>199</Words>
  <Application>Microsoft Office PowerPoint</Application>
  <PresentationFormat>Custom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ff, Andrew</dc:creator>
  <cp:lastModifiedBy>MPABLEO</cp:lastModifiedBy>
  <cp:revision>188</cp:revision>
  <dcterms:created xsi:type="dcterms:W3CDTF">2018-09-28T15:43:32Z</dcterms:created>
  <dcterms:modified xsi:type="dcterms:W3CDTF">2020-05-13T11:11:47Z</dcterms:modified>
</cp:coreProperties>
</file>